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3" d="100"/>
          <a:sy n="93" d="100"/>
        </p:scale>
        <p:origin x="1162" y="67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FCD76-95B0-4B4A-BE9D-C805BA1AD714}" type="datetimeFigureOut">
              <a:rPr lang="en-US" smtClean="0"/>
              <a:t>5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0C381-CA2C-4CFA-BE5C-E9D03238CB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67887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FCD76-95B0-4B4A-BE9D-C805BA1AD714}" type="datetimeFigureOut">
              <a:rPr lang="en-US" smtClean="0"/>
              <a:t>5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0C381-CA2C-4CFA-BE5C-E9D03238CB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19635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FCD76-95B0-4B4A-BE9D-C805BA1AD714}" type="datetimeFigureOut">
              <a:rPr lang="en-US" smtClean="0"/>
              <a:t>5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0C381-CA2C-4CFA-BE5C-E9D03238CB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20659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FCD76-95B0-4B4A-BE9D-C805BA1AD714}" type="datetimeFigureOut">
              <a:rPr lang="en-US" smtClean="0"/>
              <a:t>5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0C381-CA2C-4CFA-BE5C-E9D03238CB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23672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FCD76-95B0-4B4A-BE9D-C805BA1AD714}" type="datetimeFigureOut">
              <a:rPr lang="en-US" smtClean="0"/>
              <a:t>5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0C381-CA2C-4CFA-BE5C-E9D03238CB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37119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FCD76-95B0-4B4A-BE9D-C805BA1AD714}" type="datetimeFigureOut">
              <a:rPr lang="en-US" smtClean="0"/>
              <a:t>5/1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0C381-CA2C-4CFA-BE5C-E9D03238CB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81544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FCD76-95B0-4B4A-BE9D-C805BA1AD714}" type="datetimeFigureOut">
              <a:rPr lang="en-US" smtClean="0"/>
              <a:t>5/10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0C381-CA2C-4CFA-BE5C-E9D03238CB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03455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FCD76-95B0-4B4A-BE9D-C805BA1AD714}" type="datetimeFigureOut">
              <a:rPr lang="en-US" smtClean="0"/>
              <a:t>5/10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0C381-CA2C-4CFA-BE5C-E9D03238CB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62994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FCD76-95B0-4B4A-BE9D-C805BA1AD714}" type="datetimeFigureOut">
              <a:rPr lang="en-US" smtClean="0"/>
              <a:t>5/10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0C381-CA2C-4CFA-BE5C-E9D03238CB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62103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FCD76-95B0-4B4A-BE9D-C805BA1AD714}" type="datetimeFigureOut">
              <a:rPr lang="en-US" smtClean="0"/>
              <a:t>5/1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0C381-CA2C-4CFA-BE5C-E9D03238CB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491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FCD76-95B0-4B4A-BE9D-C805BA1AD714}" type="datetimeFigureOut">
              <a:rPr lang="en-US" smtClean="0"/>
              <a:t>5/1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0C381-CA2C-4CFA-BE5C-E9D03238CB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7322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4FCD76-95B0-4B4A-BE9D-C805BA1AD714}" type="datetimeFigureOut">
              <a:rPr lang="en-US" smtClean="0"/>
              <a:t>5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60C381-CA2C-4CFA-BE5C-E9D03238CB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73061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4800" y="1676400"/>
            <a:ext cx="8437948" cy="2743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Rectangle 2"/>
          <p:cNvSpPr/>
          <p:nvPr/>
        </p:nvSpPr>
        <p:spPr>
          <a:xfrm>
            <a:off x="304800" y="5181600"/>
            <a:ext cx="8305800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 Fig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p of T-DNA of eight different transformation constructs.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apin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Nap) and endogenous (Ep) promoters were used for </a:t>
            </a:r>
            <a:r>
              <a:rPr lang="en-US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gt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t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, respectively, for regulating the transgene expression;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ctopine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ynthase (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cspA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gene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lyA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ail was used as terminator. Bar gene (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r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under the control of 35S promoter with double enhancer was used as a selection marker. Black line below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r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represents the 500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be region used for southern hybridization</a:t>
            </a:r>
          </a:p>
        </p:txBody>
      </p:sp>
    </p:spTree>
    <p:extLst>
      <p:ext uri="{BB962C8B-B14F-4D97-AF65-F5344CB8AC3E}">
        <p14:creationId xmlns:p14="http://schemas.microsoft.com/office/powerpoint/2010/main" val="19344171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3</TotalTime>
  <Words>87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chin Kajla</dc:creator>
  <cp:lastModifiedBy>PROF. AKSHAY PRADHAN</cp:lastModifiedBy>
  <cp:revision>10</cp:revision>
  <dcterms:created xsi:type="dcterms:W3CDTF">2016-12-29T09:58:44Z</dcterms:created>
  <dcterms:modified xsi:type="dcterms:W3CDTF">2017-05-10T08:40:27Z</dcterms:modified>
</cp:coreProperties>
</file>